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41"/>
    <p:restoredTop sz="95794"/>
  </p:normalViewPr>
  <p:slideViewPr>
    <p:cSldViewPr snapToGrid="0">
      <p:cViewPr>
        <p:scale>
          <a:sx n="80" d="100"/>
          <a:sy n="80" d="100"/>
        </p:scale>
        <p:origin x="1760" y="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33E7A5-0CF4-3C58-02B1-3F2BA78FA8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A7CF28-5461-0020-880C-8B14EDA2D8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21259-2191-874C-ACDB-E7485AD01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A578DB-2510-EFC1-0D35-6AFC97B75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01668D-3CDD-1369-3758-CCA54E43A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058787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EF36E8-5D3E-B4E0-63DF-E3A99FFC4B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BEC646-A386-CEB0-93F8-823BDA2905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D0345A-EE7F-076E-EB7B-8D65241DB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A63A48-AEBE-CB9E-518E-E6FAA9975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9900BD-AE10-452B-51E0-98AC441589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19474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505C02-3FB6-B3EC-6B20-485A003993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711505-0333-836B-7B44-2822E9728A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037F1F-364B-E4B4-9548-80F49CE87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3B9684-0DD1-724D-F25C-72230908B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7715F9-812E-07AF-BF55-42A364B0C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295648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F3D14-2FB3-F624-0653-C622075FF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2E6127-14EB-D03C-78AF-2DC30E3F0D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0BA279-72E8-F558-92C2-24E8382DC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8D0F04-CB93-14B1-D78F-D2E98E8AB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743F41-19CC-E07D-A952-28EFB1003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305688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A163A-BBB3-53A8-3091-FC99C21EFA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09486B-1C8E-AC26-A6BB-7930F71BB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43AC0C-ABFF-AF84-46EB-68892D449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BAE732-FB29-76FF-1533-F576E2BA1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517270-AEC8-D875-BC02-BE3552BFF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378338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7E1CC0-893E-3B1D-F741-1A8AC99BA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0723B7-0066-8315-1B1D-24B3A06EBB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A578AC-F33E-B414-E1E8-0C4BA6A7E7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CC3FE5-BC21-1EC9-54B6-853CFCEED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DE0AA7-D87E-D1C2-4473-CF852E8EA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2C7BAB-F3BF-B29D-D992-19D475F4E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87912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7A000-AC7E-8F62-8BDB-B565863D1C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FB298B-47D4-03CD-C50C-E0725DC3CE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186831-4725-ADE0-FE0A-FF010A5C67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DDBAF5-B76E-C262-A256-10952313A7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89E060-0947-AC6F-A2C8-901AD98633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992E09-F7F7-34D1-2A70-CFC3C50A6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B48188-7B0F-A157-788A-6E9B47080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4B3CE2-1C71-9DA5-FBBE-9B4D41626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895459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DD82D-6B01-5D0D-D5DB-DE8EC225E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21B912-538B-52C7-5796-65BA7718C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650400-D2FC-AC5F-8A14-DDAD3B4B6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1F6336-A243-F40E-9BF4-DA998B5F5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42965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39FE2F-8199-8D6B-EE0D-2147D28F7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1D158C-0950-E627-3BB8-66EB4B054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49E806-0B2C-DDA1-E19F-B3859CD3A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832431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F83C9B-E629-7F81-E8C2-E51B43840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F5FE76-6960-D4B2-2306-4A4F2E776E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B209FB-EF35-A4A2-3521-AC6119A672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D05524-2AB3-0532-CE40-94A070E55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2BEB85-FF29-2867-4E03-D5A3666B1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493CE1-DE93-7D1F-67E2-5D2E6B99A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895248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712972-A855-A8AC-1578-AD11E5493F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4FE2FD-9DAE-6AB5-1A25-FE6A54085F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146438-CF71-21E2-B7A5-C149CB810F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FBA988-22A8-FEE2-6E30-55FFEEC70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209DF2-AFED-9132-C590-6BA099857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77195-A348-A7BC-AF1B-3805FEBF0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980485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E5CF38-8A94-152D-CF86-1051CC58D2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EBA65E-3434-022E-F3DD-F5A56A4BB8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4A04D5-7692-E88F-E80F-41939E5DBB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72008-622F-EC4F-84B3-5552DF55E866}" type="datetimeFigureOut">
              <a:rPr lang="en-TH" smtClean="0"/>
              <a:t>27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18A84A-75AA-F6F7-E412-829AF91682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D77A2-E8BE-DC25-7DD4-B623BE3E37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47CD8-A36C-C347-B730-B831962EB750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61932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12F6481-6D4F-F6F2-7401-CAC948F9024D}"/>
              </a:ext>
            </a:extLst>
          </p:cNvPr>
          <p:cNvSpPr txBox="1"/>
          <p:nvPr/>
        </p:nvSpPr>
        <p:spPr>
          <a:xfrm>
            <a:off x="0" y="2230642"/>
            <a:ext cx="12192000" cy="7397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TH" sz="3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1: Figure S6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65F4FD2-B99E-76B7-A800-A61175823309}"/>
              </a:ext>
            </a:extLst>
          </p:cNvPr>
          <p:cNvSpPr txBox="1"/>
          <p:nvPr/>
        </p:nvSpPr>
        <p:spPr>
          <a:xfrm>
            <a:off x="0" y="3228770"/>
            <a:ext cx="12192000" cy="6588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TH" sz="2800" b="1" dirty="0">
                <a:latin typeface="Arial" panose="020B0604020202020204" pitchFamily="34" charset="0"/>
                <a:cs typeface="Arial" panose="020B0604020202020204" pitchFamily="34" charset="0"/>
              </a:rPr>
              <a:t>Cutoff Plots</a:t>
            </a:r>
          </a:p>
        </p:txBody>
      </p:sp>
    </p:spTree>
    <p:extLst>
      <p:ext uri="{BB962C8B-B14F-4D97-AF65-F5344CB8AC3E}">
        <p14:creationId xmlns:p14="http://schemas.microsoft.com/office/powerpoint/2010/main" val="2243781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1D330D7-CA2B-06D3-9B01-AB71102C7C36}"/>
              </a:ext>
            </a:extLst>
          </p:cNvPr>
          <p:cNvSpPr txBox="1"/>
          <p:nvPr/>
        </p:nvSpPr>
        <p:spPr>
          <a:xfrm>
            <a:off x="708338" y="452669"/>
            <a:ext cx="10792496" cy="456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TH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1: Figure S6. </a:t>
            </a:r>
            <a:r>
              <a:rPr lang="en-TH" dirty="0">
                <a:latin typeface="Arial" panose="020B0604020202020204" pitchFamily="34" charset="0"/>
                <a:cs typeface="Arial" panose="020B0604020202020204" pitchFamily="34" charset="0"/>
              </a:rPr>
              <a:t>The figures show cutoff plots obtained from ROC curve analysi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08CBA01-C5F9-014E-8FC6-2C57F4937E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8439" y="947916"/>
            <a:ext cx="6492240" cy="486918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3723CAA-7303-A3C9-743C-14904A4E9102}"/>
              </a:ext>
            </a:extLst>
          </p:cNvPr>
          <p:cNvSpPr txBox="1"/>
          <p:nvPr/>
        </p:nvSpPr>
        <p:spPr>
          <a:xfrm>
            <a:off x="1165538" y="5672329"/>
            <a:ext cx="10643285" cy="11546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kern="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11</a:t>
            </a:r>
            <a:r>
              <a:rPr lang="en-US" sz="16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Figure S6.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ceiver operating characteristic (ROC) curve analysis comparing the </a:t>
            </a:r>
            <a:r>
              <a:rPr lang="en-US" sz="16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RPA–CRISPR/Cas12a assay and the standard methods (KK and/or FECT methods) for detecting </a:t>
            </a:r>
            <a:r>
              <a:rPr lang="en-US" sz="16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</a:t>
            </a:r>
            <a:r>
              <a:rPr lang="en-US" sz="16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verrini</a:t>
            </a:r>
            <a:r>
              <a:rPr lang="en-US" sz="16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fection in field-collected fecal samples 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600" i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= </a:t>
            </a:r>
            <a:r>
              <a:rPr lang="en-US" sz="1600" kern="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21</a:t>
            </a:r>
            <a:r>
              <a:rPr lang="en-US" sz="16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lang="en-TH" sz="16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6884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76</Words>
  <Application>Microsoft Macintosh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18</cp:revision>
  <dcterms:created xsi:type="dcterms:W3CDTF">2023-07-19T09:17:31Z</dcterms:created>
  <dcterms:modified xsi:type="dcterms:W3CDTF">2023-12-27T04:06:17Z</dcterms:modified>
</cp:coreProperties>
</file>